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12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54E1B9E-BEE8-F666-769B-A0BACF5D4DF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DEF332F-36F8-3A37-0006-6A4F151489F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14AB3DC-15FF-EC7F-35F7-2040D4CB40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92D7C-17A0-4513-B2B4-0F77CCF9B441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9B976F0-BFFF-BD67-3655-129AAEB542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A08FC07-5B27-C586-6F81-CA3EAADAE6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7B9D9-63BE-4EE7-9A4C-36F5444910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15958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7B64BF-E00C-A894-DC7D-5E35607694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CEDF0C4-47C0-8814-093B-10717EDD36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15DA809-1126-C901-F135-5F1ABCE0F4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92D7C-17A0-4513-B2B4-0F77CCF9B441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AEA499B-506F-82E1-9B8C-E6F24C22B0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7298326-4F77-D1C6-DA0A-8D97475AC2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7B9D9-63BE-4EE7-9A4C-36F5444910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18695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B9044F86-809A-FF1D-6B76-73B09E7070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A6AC6A1-E522-9441-3323-FF06D5C9C4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22721B6-1B0E-F7ED-2ECA-3B9623D776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92D7C-17A0-4513-B2B4-0F77CCF9B441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D3FA52B-685B-8BAF-6345-E06FF19DF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2A5415E-0BDD-E373-7FB2-97ACEB49B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7B9D9-63BE-4EE7-9A4C-36F5444910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1017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1C19A0E-20F9-32FD-F03D-0DE77D9758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DFCE049-D5D0-0BC9-1302-04E6FEFB4CE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D3C46A-401C-C143-1A6A-CCC765552E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92D7C-17A0-4513-B2B4-0F77CCF9B441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D312763-BC12-CFA3-B81B-A238F4539B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C726FEC-E1D4-17BF-3ED4-E190B13923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7B9D9-63BE-4EE7-9A4C-36F5444910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608180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8065E9-CDB6-C6C7-6442-6C5F4FAF55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0B901F8-ECDA-6E2A-6D7C-7CF8985563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AB26F9A-5B8E-4A1C-6600-DFF55F5019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92D7C-17A0-4513-B2B4-0F77CCF9B441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68612BD-BF32-102D-3DB4-1A0E924D7F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EDA45D2-CA3C-7051-77A4-7198CFAD10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7B9D9-63BE-4EE7-9A4C-36F5444910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17669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73DFA79-5A7D-5D0B-5D4F-869960C4B47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87DAB25-A3FD-2D3D-5F62-E9CBA9CD2B7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AED998B-D401-6C0B-1E63-46AC2CA331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64367F7-F524-E210-3B98-C7BBF2896B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92D7C-17A0-4513-B2B4-0F77CCF9B441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192D9DB-D647-344F-312D-4D954C4FC2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05B8CA1-2764-1076-7F1F-5FC5D5895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7B9D9-63BE-4EE7-9A4C-36F5444910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00890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627E448-214B-85F8-2DBD-5CE6C3CE2F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73A0DDA-0DF4-CE6B-8822-C23BDD1D94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9183E64-183E-3593-07B3-C8C6CAB250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6ED97332-429E-8B8B-69BC-5FE061F9272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804F4325-D3B1-1DCE-60CA-A0039501F11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2A3FEAB6-C683-0D1B-2A19-D602CEDB9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92D7C-17A0-4513-B2B4-0F77CCF9B441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CD88322-66F2-1550-B3BA-CA34C1DDF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412537F-EAC3-F43F-ADFE-EAEECFA6AC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7B9D9-63BE-4EE7-9A4C-36F5444910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62542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CD40851-3FDF-E6DE-26FB-F2AB7C46BA6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69D8C09-618A-DD82-E9B6-3B3A637238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92D7C-17A0-4513-B2B4-0F77CCF9B441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32A53BC-D53A-7AB0-F20B-9195E29CA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6DC6EEFD-D04D-25CB-59C5-A71401085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7B9D9-63BE-4EE7-9A4C-36F5444910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23146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BCE92AF6-52D2-3609-4EE9-232D561CBF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92D7C-17A0-4513-B2B4-0F77CCF9B441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5FEAFEC-20E6-05FC-D30E-850C3EDC3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4C6648AE-20F8-7240-AFCC-E281C70D4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7B9D9-63BE-4EE7-9A4C-36F5444910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8875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C851BA8-A6DD-4D02-2D6D-B42ACD834B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91CEAC9-7C0D-4BAC-9A5F-2BFD64F4CE5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FE270DF-03FE-7207-00DD-62BA0F7229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E646054-C4CB-6847-11E7-1EB1AB920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92D7C-17A0-4513-B2B4-0F77CCF9B441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A1C2975-D102-A3C2-9A38-E4ECC53FA3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F6236C8-E011-97AA-D525-45A6A94FE6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7B9D9-63BE-4EE7-9A4C-36F5444910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9851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F0EADDB-961E-6D0B-355E-D6D47568C6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3BD7587-0D77-40FF-18C5-957A8EEDA51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7210620-BEC5-5EB3-8901-0D12340774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DEF6D79-B693-99A0-207E-E01FDA2CF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B92D7C-17A0-4513-B2B4-0F77CCF9B441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F006502-FE77-994A-2CF8-349CD0A3F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EAA0DDF-BDBC-5165-C2EE-0100B83029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C7B9D9-63BE-4EE7-9A4C-36F5444910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31690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2DE8AAF-13FA-49A9-C275-32087B119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D01FE89-C0B6-9020-7B54-0A38BA9B30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6C59FB1-8F63-0CC9-1762-1132011AB3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B92D7C-17A0-4513-B2B4-0F77CCF9B441}" type="datetimeFigureOut">
              <a:rPr lang="zh-CN" altLang="en-US" smtClean="0"/>
              <a:t>2022/10/1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21DA777-E416-FE41-439F-F74D33448D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234F9E-7782-7286-0329-C21A5BAB91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C7B9D9-63BE-4EE7-9A4C-36F5444910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4810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E0FF532-C2EF-3D6B-BC8D-119515BBDBA3}"/>
              </a:ext>
            </a:extLst>
          </p:cNvPr>
          <p:cNvSpPr txBox="1"/>
          <p:nvPr/>
        </p:nvSpPr>
        <p:spPr>
          <a:xfrm>
            <a:off x="1033497" y="5353693"/>
            <a:ext cx="10864348" cy="11387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6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Fig</a:t>
            </a:r>
            <a:r>
              <a:rPr lang="en-US" altLang="zh-CN" sz="16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.S1 </a:t>
            </a:r>
            <a:r>
              <a:rPr lang="en-US" altLang="zh-CN" sz="16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Detection of 6 sample solutions by high performance liquid chromatography.</a:t>
            </a:r>
            <a:r>
              <a:rPr lang="zh-CN" altLang="en-US" sz="1600" b="1" dirty="0">
                <a:latin typeface="黑体" panose="02010609060101010101" charset="-122"/>
                <a:ea typeface="黑体" panose="02010609060101010101" charset="-122"/>
                <a:cs typeface="黑体" panose="02010609060101010101" charset="-122"/>
              </a:rPr>
              <a:t> 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A. reference solution ;</a:t>
            </a:r>
            <a:r>
              <a:rPr lang="zh-CN" altLang="en-US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B. Commercial variety symbiotic </a:t>
            </a:r>
            <a:r>
              <a:rPr lang="en-US" altLang="zh-CN" sz="16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Gastrodia</a:t>
            </a:r>
            <a:r>
              <a:rPr lang="en-US" altLang="zh-CN" sz="16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</a:t>
            </a:r>
            <a:r>
              <a:rPr lang="en-US" altLang="zh-CN" sz="16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elata</a:t>
            </a:r>
            <a:r>
              <a:rPr lang="en-US" altLang="zh-CN" sz="16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Bl. </a:t>
            </a:r>
            <a:r>
              <a:rPr lang="en-US" altLang="zh-CN" sz="16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f. glauca 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sample; C. JMG symbiotic </a:t>
            </a:r>
            <a:r>
              <a:rPr lang="en-US" altLang="zh-CN" sz="1800" kern="100" spc="75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GE</a:t>
            </a:r>
            <a:r>
              <a:rPr lang="en-US" altLang="zh-CN" sz="1800" i="1" kern="100" spc="75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f. glauca 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sample ; D. JMA symbiotic </a:t>
            </a:r>
            <a:r>
              <a:rPr lang="en-US" altLang="zh-CN" sz="18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G</a:t>
            </a:r>
            <a:r>
              <a:rPr lang="en-US" altLang="zh-CN" sz="18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.</a:t>
            </a:r>
            <a:r>
              <a:rPr lang="zh-CN" altLang="en-US" sz="18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elata</a:t>
            </a:r>
            <a:r>
              <a:rPr lang="en-US" altLang="zh-CN" sz="1800" i="1" kern="100" spc="75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f. glauca 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sample ; E. JMB symbiotic </a:t>
            </a:r>
            <a:r>
              <a:rPr lang="en-US" altLang="zh-CN" sz="18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G</a:t>
            </a:r>
            <a:r>
              <a:rPr lang="en-US" altLang="zh-CN" sz="18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.</a:t>
            </a:r>
            <a:r>
              <a:rPr lang="zh-CN" altLang="en-US" sz="18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</a:t>
            </a:r>
            <a:r>
              <a:rPr lang="en-US" altLang="zh-CN" sz="18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elata</a:t>
            </a:r>
            <a:r>
              <a:rPr lang="en-US" altLang="zh-CN" sz="1800" i="1" kern="100" spc="75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f. glauca 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sample ;</a:t>
            </a:r>
            <a:r>
              <a:rPr lang="zh-CN" altLang="en-US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F. JMD symbiotic </a:t>
            </a:r>
            <a:r>
              <a:rPr lang="en-US" altLang="zh-CN" sz="1800" kern="100" spc="75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GE</a:t>
            </a:r>
            <a:r>
              <a:rPr lang="en-US" altLang="zh-CN" sz="1800" i="1" kern="100" spc="75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 f. glauca 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sample. 1. </a:t>
            </a:r>
            <a:r>
              <a:rPr lang="en-US" altLang="zh-CN" sz="16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gastrodin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; 2. p-hydroxybenzyl alcohol; 3. </a:t>
            </a:r>
            <a:r>
              <a:rPr lang="en-US" altLang="zh-CN" sz="16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parishin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E; 4. </a:t>
            </a:r>
            <a:r>
              <a:rPr lang="en-US" altLang="zh-CN" sz="16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parishin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B; 5. </a:t>
            </a:r>
            <a:r>
              <a:rPr lang="en-US" altLang="zh-CN" sz="16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parishin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C; 6. </a:t>
            </a:r>
            <a:r>
              <a:rPr lang="en-US" altLang="zh-CN" sz="16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parishin</a:t>
            </a:r>
            <a:r>
              <a:rPr lang="en-US" altLang="zh-CN" sz="1600" kern="100" dirty="0">
                <a:solidFill>
                  <a:srgbClr val="000000"/>
                </a:solidFill>
                <a:latin typeface="Times New Roman" panose="02020603050405020304" pitchFamily="18" charset="0"/>
                <a:ea typeface="黑体" panose="02010609060101010101" pitchFamily="49" charset="-122"/>
                <a:cs typeface="Times New Roman" panose="02020603050405020304" pitchFamily="18" charset="0"/>
              </a:rPr>
              <a:t> A.</a:t>
            </a:r>
            <a:endParaRPr lang="zh-CN" altLang="en-US" sz="1600" kern="100" dirty="0">
              <a:solidFill>
                <a:srgbClr val="000000"/>
              </a:solidFill>
              <a:latin typeface="Times New Roman" panose="02020603050405020304" pitchFamily="18" charset="0"/>
              <a:ea typeface="黑体" panose="02010609060101010101" pitchFamily="49" charset="-122"/>
              <a:cs typeface="Times New Roman" panose="02020603050405020304" pitchFamily="18" charset="0"/>
            </a:endParaRPr>
          </a:p>
        </p:txBody>
      </p:sp>
      <p:pic>
        <p:nvPicPr>
          <p:cNvPr id="6" name="图片 222" descr="混标">
            <a:extLst>
              <a:ext uri="{FF2B5EF4-FFF2-40B4-BE49-F238E27FC236}">
                <a16:creationId xmlns:a16="http://schemas.microsoft.com/office/drawing/2014/main" id="{6CC03BEF-BE89-62D6-E868-8DAC24E4457B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817563" y="525145"/>
            <a:ext cx="3600000" cy="2160270"/>
          </a:xfrm>
          <a:prstGeom prst="rect">
            <a:avLst/>
          </a:prstGeom>
        </p:spPr>
      </p:pic>
      <p:pic>
        <p:nvPicPr>
          <p:cNvPr id="7" name="图片 223" descr="C">
            <a:extLst>
              <a:ext uri="{FF2B5EF4-FFF2-40B4-BE49-F238E27FC236}">
                <a16:creationId xmlns:a16="http://schemas.microsoft.com/office/drawing/2014/main" id="{78103944-CCCF-5C0B-3F5A-E4528B04092F}"/>
              </a:ext>
            </a:extLst>
          </p:cNvPr>
          <p:cNvPicPr/>
          <p:nvPr/>
        </p:nvPicPr>
        <p:blipFill>
          <a:blip r:embed="rId3"/>
          <a:stretch>
            <a:fillRect/>
          </a:stretch>
        </p:blipFill>
        <p:spPr>
          <a:xfrm>
            <a:off x="4520433" y="525145"/>
            <a:ext cx="3599815" cy="2160270"/>
          </a:xfrm>
          <a:prstGeom prst="rect">
            <a:avLst/>
          </a:prstGeom>
        </p:spPr>
      </p:pic>
      <p:pic>
        <p:nvPicPr>
          <p:cNvPr id="8" name="图片 224" descr="A">
            <a:extLst>
              <a:ext uri="{FF2B5EF4-FFF2-40B4-BE49-F238E27FC236}">
                <a16:creationId xmlns:a16="http://schemas.microsoft.com/office/drawing/2014/main" id="{35E9C585-AEFA-C183-7C52-A229D4CC2034}"/>
              </a:ext>
            </a:extLst>
          </p:cNvPr>
          <p:cNvPicPr/>
          <p:nvPr/>
        </p:nvPicPr>
        <p:blipFill>
          <a:blip r:embed="rId4"/>
          <a:stretch>
            <a:fillRect/>
          </a:stretch>
        </p:blipFill>
        <p:spPr>
          <a:xfrm>
            <a:off x="8223118" y="525145"/>
            <a:ext cx="3599815" cy="2160270"/>
          </a:xfrm>
          <a:prstGeom prst="rect">
            <a:avLst/>
          </a:prstGeom>
        </p:spPr>
      </p:pic>
      <p:pic>
        <p:nvPicPr>
          <p:cNvPr id="9" name="图片 225" descr="B">
            <a:extLst>
              <a:ext uri="{FF2B5EF4-FFF2-40B4-BE49-F238E27FC236}">
                <a16:creationId xmlns:a16="http://schemas.microsoft.com/office/drawing/2014/main" id="{43D3A605-7607-B575-44F9-42FEED3CE4A2}"/>
              </a:ext>
            </a:extLst>
          </p:cNvPr>
          <p:cNvPicPr/>
          <p:nvPr/>
        </p:nvPicPr>
        <p:blipFill>
          <a:blip r:embed="rId5"/>
          <a:stretch>
            <a:fillRect/>
          </a:stretch>
        </p:blipFill>
        <p:spPr>
          <a:xfrm>
            <a:off x="817563" y="2932430"/>
            <a:ext cx="3600000" cy="2160270"/>
          </a:xfrm>
          <a:prstGeom prst="rect">
            <a:avLst/>
          </a:prstGeom>
        </p:spPr>
      </p:pic>
      <p:pic>
        <p:nvPicPr>
          <p:cNvPr id="10" name="图片 4" descr="C-1(D-1)">
            <a:extLst>
              <a:ext uri="{FF2B5EF4-FFF2-40B4-BE49-F238E27FC236}">
                <a16:creationId xmlns:a16="http://schemas.microsoft.com/office/drawing/2014/main" id="{DE2789ED-759C-5C42-83B8-E0C95AC99EE1}"/>
              </a:ext>
            </a:extLst>
          </p:cNvPr>
          <p:cNvPicPr/>
          <p:nvPr/>
        </p:nvPicPr>
        <p:blipFill>
          <a:blip r:embed="rId6"/>
          <a:stretch>
            <a:fillRect/>
          </a:stretch>
        </p:blipFill>
        <p:spPr>
          <a:xfrm>
            <a:off x="4520433" y="2932430"/>
            <a:ext cx="3599815" cy="2160270"/>
          </a:xfrm>
          <a:prstGeom prst="rect">
            <a:avLst/>
          </a:prstGeom>
        </p:spPr>
      </p:pic>
      <p:pic>
        <p:nvPicPr>
          <p:cNvPr id="11" name="图片 6" descr="A-2（E-1）">
            <a:extLst>
              <a:ext uri="{FF2B5EF4-FFF2-40B4-BE49-F238E27FC236}">
                <a16:creationId xmlns:a16="http://schemas.microsoft.com/office/drawing/2014/main" id="{AFA9C6B5-481E-F7D2-52B9-4410BF34BD95}"/>
              </a:ext>
            </a:extLst>
          </p:cNvPr>
          <p:cNvPicPr/>
          <p:nvPr/>
        </p:nvPicPr>
        <p:blipFill>
          <a:blip r:embed="rId7"/>
          <a:stretch>
            <a:fillRect/>
          </a:stretch>
        </p:blipFill>
        <p:spPr>
          <a:xfrm>
            <a:off x="8223118" y="2932430"/>
            <a:ext cx="3599815" cy="216000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0BF70EC0-396C-0D8F-BECB-64A790CAEA20}"/>
              </a:ext>
            </a:extLst>
          </p:cNvPr>
          <p:cNvSpPr txBox="1"/>
          <p:nvPr/>
        </p:nvSpPr>
        <p:spPr>
          <a:xfrm>
            <a:off x="597159" y="447869"/>
            <a:ext cx="2204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A</a:t>
            </a:r>
            <a:endParaRPr lang="zh-CN" altLang="en-US" sz="12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914E7154-C457-849F-124B-CB791FF24C00}"/>
              </a:ext>
            </a:extLst>
          </p:cNvPr>
          <p:cNvSpPr txBox="1"/>
          <p:nvPr/>
        </p:nvSpPr>
        <p:spPr>
          <a:xfrm>
            <a:off x="4410231" y="445874"/>
            <a:ext cx="2204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B</a:t>
            </a:r>
            <a:endParaRPr lang="zh-CN" altLang="en-US" sz="12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D7DD8CA-777C-0D43-0501-B3585C1A6064}"/>
              </a:ext>
            </a:extLst>
          </p:cNvPr>
          <p:cNvSpPr txBox="1"/>
          <p:nvPr/>
        </p:nvSpPr>
        <p:spPr>
          <a:xfrm>
            <a:off x="8112916" y="445873"/>
            <a:ext cx="2204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C</a:t>
            </a:r>
            <a:endParaRPr lang="zh-CN" altLang="en-US" sz="1200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50145E1-CFFE-F1BB-FBB0-6ACC9B4A62CE}"/>
              </a:ext>
            </a:extLst>
          </p:cNvPr>
          <p:cNvSpPr txBox="1"/>
          <p:nvPr/>
        </p:nvSpPr>
        <p:spPr>
          <a:xfrm>
            <a:off x="655926" y="2871128"/>
            <a:ext cx="2204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D</a:t>
            </a:r>
            <a:endParaRPr lang="zh-CN" altLang="en-US" sz="1200" dirty="0"/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8430665-52F4-9B80-B480-93449F3670EB}"/>
              </a:ext>
            </a:extLst>
          </p:cNvPr>
          <p:cNvSpPr txBox="1"/>
          <p:nvPr/>
        </p:nvSpPr>
        <p:spPr>
          <a:xfrm>
            <a:off x="4426473" y="2871127"/>
            <a:ext cx="2204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E</a:t>
            </a:r>
            <a:endParaRPr lang="zh-CN" altLang="en-US" sz="1200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6747554-1DF0-16D5-29FB-FD714E979C61}"/>
              </a:ext>
            </a:extLst>
          </p:cNvPr>
          <p:cNvSpPr txBox="1"/>
          <p:nvPr/>
        </p:nvSpPr>
        <p:spPr>
          <a:xfrm>
            <a:off x="8112916" y="2871126"/>
            <a:ext cx="2204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/>
              <a:t>F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0549445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2</TotalTime>
  <Words>112</Words>
  <Application>Microsoft Office PowerPoint</Application>
  <PresentationFormat>宽屏</PresentationFormat>
  <Paragraphs>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黑体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E</dc:creator>
  <cp:lastModifiedBy>YE</cp:lastModifiedBy>
  <cp:revision>7</cp:revision>
  <dcterms:created xsi:type="dcterms:W3CDTF">2022-07-13T13:24:05Z</dcterms:created>
  <dcterms:modified xsi:type="dcterms:W3CDTF">2022-10-19T14:48:21Z</dcterms:modified>
</cp:coreProperties>
</file>